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8" r:id="rId3"/>
    <p:sldId id="259" r:id="rId4"/>
    <p:sldId id="257" r:id="rId5"/>
    <p:sldId id="260" r:id="rId6"/>
    <p:sldId id="261" r:id="rId7"/>
    <p:sldId id="262" r:id="rId8"/>
    <p:sldId id="263" r:id="rId9"/>
    <p:sldId id="264" r:id="rId10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3972"/>
    <p:restoredTop sz="94623"/>
  </p:normalViewPr>
  <p:slideViewPr>
    <p:cSldViewPr snapToGrid="0" snapToObjects="1">
      <p:cViewPr varScale="1">
        <p:scale>
          <a:sx n="101" d="100"/>
          <a:sy n="101" d="100"/>
        </p:scale>
        <p:origin x="520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DFA0F86-1C41-5841-B7D9-B40515A78D2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CA"/>
              <a:t>Modifier le style du titre</a:t>
            </a:r>
            <a:endParaRPr lang="en-GB"/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06902958-8FEE-CC43-95A7-716D92E7DF2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CA"/>
              <a:t>Modifier le style des sous-titres du masque</a:t>
            </a:r>
            <a:endParaRPr lang="en-GB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98916AE7-E193-CF48-BBF5-1D0C7C3268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A5220-55CB-714C-AA2D-13C2C8EA8448}" type="datetimeFigureOut">
              <a:rPr lang="en-GB" smtClean="0"/>
              <a:t>03/06/2022</a:t>
            </a:fld>
            <a:endParaRPr lang="en-GB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4A67D4A-24DA-6342-B630-B09EAF27D9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EBF7579-FA60-3744-8687-831214A2C1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66C34-93CD-8D44-AA37-68DD3AA12631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71388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79BBD9F-A1AF-F841-81F8-AD8B16D6A4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/>
              <a:t>Modifier le style du titre</a:t>
            </a:r>
            <a:endParaRPr lang="en-GB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FF6D1B7E-1997-7D4E-80D5-DC6211999DB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GB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BC912BA-84AD-8745-B87B-2DBDBD51B2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A5220-55CB-714C-AA2D-13C2C8EA8448}" type="datetimeFigureOut">
              <a:rPr lang="en-GB" smtClean="0"/>
              <a:t>03/06/2022</a:t>
            </a:fld>
            <a:endParaRPr lang="en-GB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131A455-5722-B84F-A879-F88038446A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28DE0A5-A4E4-C449-9E61-EC769E28F5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66C34-93CD-8D44-AA37-68DD3AA12631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45504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38CC67F7-63F7-1248-833B-E61ECC227C5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CA"/>
              <a:t>Modifier le style du titre</a:t>
            </a:r>
            <a:endParaRPr lang="en-GB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D1FDF55E-7135-4243-97A0-2CC6871510C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GB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BD2FA76-2EF0-1F47-BEC3-08F6923001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A5220-55CB-714C-AA2D-13C2C8EA8448}" type="datetimeFigureOut">
              <a:rPr lang="en-GB" smtClean="0"/>
              <a:t>03/06/2022</a:t>
            </a:fld>
            <a:endParaRPr lang="en-GB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23B5518-0CEE-EB4A-9638-10FE4CFF61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008ED0B-BE28-E64B-9707-99B3BB5928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66C34-93CD-8D44-AA37-68DD3AA12631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73264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E7317E0-C819-E94C-A44D-ADCE449EA9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/>
              <a:t>Modifier le style du titre</a:t>
            </a:r>
            <a:endParaRPr lang="en-GB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240AD5D6-3B2D-9547-B5CB-4F4993F38A2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GB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02E6F73-8E9C-F148-891B-3868C05510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A5220-55CB-714C-AA2D-13C2C8EA8448}" type="datetimeFigureOut">
              <a:rPr lang="en-GB" smtClean="0"/>
              <a:t>03/06/2022</a:t>
            </a:fld>
            <a:endParaRPr lang="en-GB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C79E86B-F9BA-2948-AF61-1B9BA2E4FA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8906377-731C-C445-A29E-520A997831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66C34-93CD-8D44-AA37-68DD3AA12631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73208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C4D18C3-4D13-9745-A947-763B56025D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CA"/>
              <a:t>Modifier le style du titre</a:t>
            </a:r>
            <a:endParaRPr lang="en-GB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FF899820-36B4-0D4A-8AF5-906A49B83E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CA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C5C4F9D-4570-B24E-AC31-C6EF794763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A5220-55CB-714C-AA2D-13C2C8EA8448}" type="datetimeFigureOut">
              <a:rPr lang="en-GB" smtClean="0"/>
              <a:t>03/06/2022</a:t>
            </a:fld>
            <a:endParaRPr lang="en-GB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3F9D46E-42BF-E245-9B81-9C2D05B223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7FB3CFB-947C-C44C-89A9-ACF91AE798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66C34-93CD-8D44-AA37-68DD3AA12631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34750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24009F3-E685-CF4E-BF67-44D3F42D29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/>
              <a:t>Modifier le style du titre</a:t>
            </a:r>
            <a:endParaRPr lang="en-GB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9DCCC616-11D6-C641-BE74-C128B496904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GB"/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F9EB8D48-C70F-F547-A739-EFC31971B3E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GB"/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0711BDFB-3393-E043-AECA-3CA488BE03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A5220-55CB-714C-AA2D-13C2C8EA8448}" type="datetimeFigureOut">
              <a:rPr lang="en-GB" smtClean="0"/>
              <a:t>03/06/2022</a:t>
            </a:fld>
            <a:endParaRPr lang="en-GB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9F650B10-0522-D549-B7AE-F49C279C1E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55A0487F-20B4-AF45-8197-687408FF97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66C34-93CD-8D44-AA37-68DD3AA12631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31579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ECF26BF-7F49-A744-939B-6612E29E84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CA"/>
              <a:t>Modifier le style du titre</a:t>
            </a:r>
            <a:endParaRPr lang="en-GB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B58D2AA9-BE92-6344-90FC-1AB86BC100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A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DF69C586-B6F1-EE41-B9AA-02352FA504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GB"/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9E677AEB-B455-9B44-B0C1-D7BF2D45FCC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A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B6810801-D071-D045-B4F5-2D4994AB01A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GB"/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03B7DFA4-BCF8-E14E-8FD0-81DC2F18F7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A5220-55CB-714C-AA2D-13C2C8EA8448}" type="datetimeFigureOut">
              <a:rPr lang="en-GB" smtClean="0"/>
              <a:t>03/06/2022</a:t>
            </a:fld>
            <a:endParaRPr lang="en-GB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257415B8-1634-4440-B911-BD0BC47B59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874E454E-B584-CA47-8BC4-F47C5E05B5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66C34-93CD-8D44-AA37-68DD3AA12631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65378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9476F68-2314-7149-AF80-FD18CCD5E9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/>
              <a:t>Modifier le style du titre</a:t>
            </a:r>
            <a:endParaRPr lang="en-GB"/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0C518F08-6E4B-3B44-9902-51FC8777F3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A5220-55CB-714C-AA2D-13C2C8EA8448}" type="datetimeFigureOut">
              <a:rPr lang="en-GB" smtClean="0"/>
              <a:t>03/06/2022</a:t>
            </a:fld>
            <a:endParaRPr lang="en-GB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1B6BA668-36F1-994E-B038-C8E24AB28D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03CD00A0-089E-AF40-B7BA-6C12D7EAA6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66C34-93CD-8D44-AA37-68DD3AA12631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87686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0844DDF8-56BD-BD43-8492-293A26DAC5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A5220-55CB-714C-AA2D-13C2C8EA8448}" type="datetimeFigureOut">
              <a:rPr lang="en-GB" smtClean="0"/>
              <a:t>03/06/2022</a:t>
            </a:fld>
            <a:endParaRPr lang="en-GB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196198DD-AA03-7944-9025-A80FC95AF1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69A1A362-78CD-BC4D-B116-9107F7A4F6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66C34-93CD-8D44-AA37-68DD3AA12631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432485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419FDDA-DDB6-4C4B-82B2-5B7CEAC1E6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CA"/>
              <a:t>Modifier le style du titre</a:t>
            </a:r>
            <a:endParaRPr lang="en-GB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40BB11C4-D9A8-9C40-BDAD-EF0FCB4F4FF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GB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91773AF3-5933-F24E-88F3-834BC358710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CA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BD41087-5BB3-FB41-B1D7-318532FA65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A5220-55CB-714C-AA2D-13C2C8EA8448}" type="datetimeFigureOut">
              <a:rPr lang="en-GB" smtClean="0"/>
              <a:t>03/06/2022</a:t>
            </a:fld>
            <a:endParaRPr lang="en-GB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6E2EE7E-D82C-0A4A-A11E-55F553A054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635DB20D-40E4-F646-B02C-276A7ECFFB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66C34-93CD-8D44-AA37-68DD3AA12631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81836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475E9E5-DFCA-144E-8870-1EE9DF96A8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CA"/>
              <a:t>Modifier le style du titre</a:t>
            </a:r>
            <a:endParaRPr lang="en-GB"/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8D551333-9CBE-E441-A2B2-F5F52AF1669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2923CBED-6FB3-B145-B11F-1E72C49D1A2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CA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C1988F30-5C49-A54A-9566-D90DA98FDD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A5220-55CB-714C-AA2D-13C2C8EA8448}" type="datetimeFigureOut">
              <a:rPr lang="en-GB" smtClean="0"/>
              <a:t>03/06/2022</a:t>
            </a:fld>
            <a:endParaRPr lang="en-GB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EC2A53AF-6A0F-A344-8FFA-3D3812AB92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9B90F6D8-0BED-8746-9484-D6AC545595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66C34-93CD-8D44-AA37-68DD3AA12631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75346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4B6807A2-BF47-064F-A6FE-3C2AE65974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CA"/>
              <a:t>Modifier le style du titre</a:t>
            </a:r>
            <a:endParaRPr lang="en-GB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3B1B42B9-E837-5147-BE78-4275FD346D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GB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3612834-8547-8842-95C4-9B4BCAC5263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BA5220-55CB-714C-AA2D-13C2C8EA8448}" type="datetimeFigureOut">
              <a:rPr lang="en-GB" smtClean="0"/>
              <a:t>03/06/2022</a:t>
            </a:fld>
            <a:endParaRPr lang="en-GB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48AA418-014F-7D4E-BEA7-48EA895A71D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AB90FE5-E3C3-F148-85A0-F5FE4E6F2E1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766C34-93CD-8D44-AA37-68DD3AA12631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81185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5FACA968-2D8C-7C44-84CE-F109656AE64F}"/>
              </a:ext>
            </a:extLst>
          </p:cNvPr>
          <p:cNvSpPr/>
          <p:nvPr/>
        </p:nvSpPr>
        <p:spPr>
          <a:xfrm>
            <a:off x="1036864" y="89721"/>
            <a:ext cx="10118271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dditional file 1.</a:t>
            </a:r>
            <a:r>
              <a:rPr lang="en-CA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velopmental trajectories of eating disorder symptoms: A longitudinal study from early adolescence to young adulthood</a:t>
            </a:r>
            <a:endParaRPr lang="fr-CA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Breton, Dufour, et al. </a:t>
            </a:r>
            <a:endParaRPr lang="fr-CA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spcAft>
                <a:spcPts val="0"/>
              </a:spcAft>
            </a:pPr>
            <a:endParaRPr lang="fr-CA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DF128B96-D7EE-524B-BC76-F0657A64AA08}"/>
              </a:ext>
            </a:extLst>
          </p:cNvPr>
          <p:cNvSpPr/>
          <p:nvPr/>
        </p:nvSpPr>
        <p:spPr>
          <a:xfrm>
            <a:off x="559043" y="1290050"/>
            <a:ext cx="59234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.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odel of overall ED symptoms (with the weight loss item)</a:t>
            </a:r>
            <a:endParaRPr lang="fr-CA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6" name="Image 5">
            <a:extLst>
              <a:ext uri="{FF2B5EF4-FFF2-40B4-BE49-F238E27FC236}">
                <a16:creationId xmlns:a16="http://schemas.microsoft.com/office/drawing/2014/main" id="{6B51AC31-9E20-6B47-9F68-0241BFFA569E}"/>
              </a:ext>
            </a:extLst>
          </p:cNvPr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394"/>
          <a:stretch/>
        </p:blipFill>
        <p:spPr bwMode="auto">
          <a:xfrm>
            <a:off x="1161272" y="1763486"/>
            <a:ext cx="9869456" cy="5094514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  <p:extLst>
      <p:ext uri="{BB962C8B-B14F-4D97-AF65-F5344CB8AC3E}">
        <p14:creationId xmlns:p14="http://schemas.microsoft.com/office/powerpoint/2010/main" val="5117388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DF128B96-D7EE-524B-BC76-F0657A64AA08}"/>
              </a:ext>
            </a:extLst>
          </p:cNvPr>
          <p:cNvSpPr/>
          <p:nvPr/>
        </p:nvSpPr>
        <p:spPr>
          <a:xfrm>
            <a:off x="559043" y="669085"/>
            <a:ext cx="408316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.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odel of overall ED symptoms in girls</a:t>
            </a:r>
            <a:endParaRPr lang="fr-CA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id="{55C0776C-E5B1-D848-82CF-A3A8C416005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2754" b="8286"/>
          <a:stretch/>
        </p:blipFill>
        <p:spPr>
          <a:xfrm>
            <a:off x="22745" y="1427583"/>
            <a:ext cx="12169255" cy="49918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710384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DF128B96-D7EE-524B-BC76-F0657A64AA08}"/>
              </a:ext>
            </a:extLst>
          </p:cNvPr>
          <p:cNvSpPr/>
          <p:nvPr/>
        </p:nvSpPr>
        <p:spPr>
          <a:xfrm>
            <a:off x="559043" y="669085"/>
            <a:ext cx="412164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.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odel of overall ED symptoms in boys</a:t>
            </a:r>
            <a:endParaRPr lang="fr-CA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id="{9F4E5310-4884-8743-A845-717B632EAB7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2629" b="18555"/>
          <a:stretch/>
        </p:blipFill>
        <p:spPr>
          <a:xfrm>
            <a:off x="442920" y="1172938"/>
            <a:ext cx="11349788" cy="48546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062160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DF128B96-D7EE-524B-BC76-F0657A64AA08}"/>
              </a:ext>
            </a:extLst>
          </p:cNvPr>
          <p:cNvSpPr/>
          <p:nvPr/>
        </p:nvSpPr>
        <p:spPr>
          <a:xfrm>
            <a:off x="559043" y="669085"/>
            <a:ext cx="620554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.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odel of overall ED symptoms </a:t>
            </a:r>
            <a:r>
              <a:rPr lang="en-US" u="sng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without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weight loss item)</a:t>
            </a:r>
            <a:endParaRPr lang="fr-CA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id="{A3D3BFEB-3909-2942-B842-13223776EE1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4531" y="1745201"/>
            <a:ext cx="11982937" cy="49475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4944969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DF128B96-D7EE-524B-BC76-F0657A64AA08}"/>
              </a:ext>
            </a:extLst>
          </p:cNvPr>
          <p:cNvSpPr/>
          <p:nvPr/>
        </p:nvSpPr>
        <p:spPr>
          <a:xfrm>
            <a:off x="559043" y="669085"/>
            <a:ext cx="423930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.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odel for each symptom type – purging </a:t>
            </a:r>
            <a:endParaRPr lang="fr-CA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8" name="Image 7">
            <a:extLst>
              <a:ext uri="{FF2B5EF4-FFF2-40B4-BE49-F238E27FC236}">
                <a16:creationId xmlns:a16="http://schemas.microsoft.com/office/drawing/2014/main" id="{5E6331E2-6A31-BD44-8D08-E7F0A66E5F8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3304" b="5047"/>
          <a:stretch/>
        </p:blipFill>
        <p:spPr>
          <a:xfrm>
            <a:off x="130313" y="1322227"/>
            <a:ext cx="11931373" cy="46415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0179565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DF128B96-D7EE-524B-BC76-F0657A64AA08}"/>
              </a:ext>
            </a:extLst>
          </p:cNvPr>
          <p:cNvSpPr/>
          <p:nvPr/>
        </p:nvSpPr>
        <p:spPr>
          <a:xfrm>
            <a:off x="559043" y="669085"/>
            <a:ext cx="48058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.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odel for each symptom type – loss of control</a:t>
            </a:r>
            <a:endParaRPr lang="fr-CA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id="{E135159F-B84D-6E45-BB44-20210952300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4637"/>
          <a:stretch/>
        </p:blipFill>
        <p:spPr>
          <a:xfrm>
            <a:off x="147921" y="1500282"/>
            <a:ext cx="11896157" cy="45933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2132680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DF128B96-D7EE-524B-BC76-F0657A64AA08}"/>
              </a:ext>
            </a:extLst>
          </p:cNvPr>
          <p:cNvSpPr/>
          <p:nvPr/>
        </p:nvSpPr>
        <p:spPr>
          <a:xfrm>
            <a:off x="559043" y="669085"/>
            <a:ext cx="453842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.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odel for each symptom type – loss weight</a:t>
            </a:r>
            <a:endParaRPr lang="fr-CA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6" name="Image 5">
            <a:extLst>
              <a:ext uri="{FF2B5EF4-FFF2-40B4-BE49-F238E27FC236}">
                <a16:creationId xmlns:a16="http://schemas.microsoft.com/office/drawing/2014/main" id="{21CD2B58-69C1-BA40-8861-6A29CAD904F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3166"/>
          <a:stretch/>
        </p:blipFill>
        <p:spPr>
          <a:xfrm>
            <a:off x="351200" y="1441693"/>
            <a:ext cx="11489599" cy="47472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0070342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DF128B96-D7EE-524B-BC76-F0657A64AA08}"/>
              </a:ext>
            </a:extLst>
          </p:cNvPr>
          <p:cNvSpPr/>
          <p:nvPr/>
        </p:nvSpPr>
        <p:spPr>
          <a:xfrm>
            <a:off x="559043" y="669085"/>
            <a:ext cx="373692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.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odel for each symptom type – fat</a:t>
            </a:r>
            <a:endParaRPr lang="fr-CA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id="{2EAD6A72-C80E-904C-B6B8-6D57D4E295F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7471"/>
          <a:stretch/>
        </p:blipFill>
        <p:spPr>
          <a:xfrm>
            <a:off x="147704" y="1542593"/>
            <a:ext cx="11896591" cy="46463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0693660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DF128B96-D7EE-524B-BC76-F0657A64AA08}"/>
              </a:ext>
            </a:extLst>
          </p:cNvPr>
          <p:cNvSpPr/>
          <p:nvPr/>
        </p:nvSpPr>
        <p:spPr>
          <a:xfrm>
            <a:off x="559043" y="669085"/>
            <a:ext cx="382668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.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odel for each symptom type – food</a:t>
            </a:r>
            <a:endParaRPr lang="fr-CA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6" name="Image 5">
            <a:extLst>
              <a:ext uri="{FF2B5EF4-FFF2-40B4-BE49-F238E27FC236}">
                <a16:creationId xmlns:a16="http://schemas.microsoft.com/office/drawing/2014/main" id="{9F3C258C-2E21-6447-9052-44538483F02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3334"/>
          <a:stretch/>
        </p:blipFill>
        <p:spPr>
          <a:xfrm>
            <a:off x="186612" y="1172938"/>
            <a:ext cx="12005388" cy="45967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281341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121</Words>
  <Application>Microsoft Macintosh PowerPoint</Application>
  <PresentationFormat>Grand écran</PresentationFormat>
  <Paragraphs>11</Paragraphs>
  <Slides>9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9</vt:i4>
      </vt:variant>
    </vt:vector>
  </HeadingPairs>
  <TitlesOfParts>
    <vt:vector size="14" baseType="lpstr">
      <vt:lpstr>Arial</vt:lpstr>
      <vt:lpstr>Calibri</vt:lpstr>
      <vt:lpstr>Calibri Light</vt:lpstr>
      <vt:lpstr>Times New Roman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Édith Breton</dc:creator>
  <cp:lastModifiedBy>Édith Breton</cp:lastModifiedBy>
  <cp:revision>5</cp:revision>
  <dcterms:created xsi:type="dcterms:W3CDTF">2022-05-27T19:00:34Z</dcterms:created>
  <dcterms:modified xsi:type="dcterms:W3CDTF">2022-06-03T13:04:38Z</dcterms:modified>
</cp:coreProperties>
</file>